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F297EF-433C-4128-8E1D-43D3AD10D46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9EE95A-C86F-4585-ABB8-F371D4B1D14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FF07F3-EFD6-4D65-BD81-643355DBE1E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103412-E08C-4615-96E2-458CEEFF9BF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0F6B72-CDEB-4E6F-9BD2-17BB57E9D69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D7891D-9CBC-40CC-B722-7305760B3B7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6E8752-96D5-4B52-A263-353938F0B35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C24247-972B-4846-8EEC-D521217456F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4C5444-6C69-4D2D-B0C5-B27D383DF31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109554-64D8-4C1C-95C9-DD13A885242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D30286-6EFD-488E-B835-AB50D6DF018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C0E616-4757-4FF9-921B-C0BBF03562A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015BF32-146B-4FAD-862D-8041B97D494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380880" y="5715000"/>
            <a:ext cx="8229600" cy="838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 S5: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Conditioning on Arsenic metabolism SNPs did not show any effect on the HR of the genomic segments (adjusted for gender, age &amp; UACR)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2057400" y="0"/>
            <a:ext cx="4835520" cy="54864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8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1-23T22:36:52Z</dcterms:created>
  <dc:creator>mkibriya</dc:creator>
  <dc:description/>
  <dc:language>en-US</dc:language>
  <cp:lastModifiedBy>mkibriya</cp:lastModifiedBy>
  <dcterms:modified xsi:type="dcterms:W3CDTF">2017-03-29T18:45:08Z</dcterms:modified>
  <cp:revision>36</cp:revision>
  <dc:subject/>
  <dc:title>Slide 1</dc:title>
</cp:coreProperties>
</file>